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53754-55CA-4671-8C27-786E1FEA0A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0FF19-BA46-4BD4-B0CE-05785DC751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B063C-65E7-4012-912A-6B65F41ED2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9D268-85DE-411C-860F-62D8F7FEBF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11C5C-638B-4018-AB18-F8D2EAF888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7B2EA-DFCD-4E14-9F1F-FCF52674E5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C0B83D-EC1A-4BFA-9848-6B0A48B1F8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746F3-ECA0-46D5-BCE6-7B7E3BA3AF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FB9C2-D957-4509-A1CA-8C8E9B85DF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100EE-3E6F-4EC5-AB6B-91E9A257AC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3DADA-EB25-4C47-B9AE-8A8337D045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5A168-7F08-42B6-822F-3555744E7E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E51821-36C5-4CBC-8268-82132F959ED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0" y="227880"/>
            <a:ext cx="621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   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7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"/>
          <p:cNvSpPr/>
          <p:nvPr/>
        </p:nvSpPr>
        <p:spPr>
          <a:xfrm>
            <a:off x="0" y="6253200"/>
            <a:ext cx="621828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Effect of N-acetyl-cysteine (NAC, 0.5 and 5 mmol/L) intervention on menadione toxicity in each FAO disorder under variable conditions.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Paired t-test compares each FAOD, with and without NAC, under each experimental condition after logarithmic transformation.  NAC was significantly effective for SCADD, CPT2/MTPD and MCADD patient fibroblasts under all experimental conditions.  In the control fibroblasts, NAC at 5 mmol/L was effective under all experimental conditions.   ^ p&lt;0.05 *p&lt;0.01** p&lt;0.001 *** p&lt;0.0005 **** p&lt;0.0001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290520" y="762120"/>
          <a:ext cx="5668920" cy="5155920"/>
        </p:xfrm>
        <a:graphic>
          <a:graphicData uri="http://schemas.openxmlformats.org/drawingml/2006/table">
            <a:tbl>
              <a:tblPr/>
              <a:tblGrid>
                <a:gridCol w="1144440"/>
                <a:gridCol w="1132200"/>
                <a:gridCol w="1130040"/>
                <a:gridCol w="1130400"/>
                <a:gridCol w="1131840"/>
              </a:tblGrid>
              <a:tr h="52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16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86.2 ± 15.5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6. 4± 22.4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9.6 ± 8.2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3.4 ± 6.3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6.9 ± 15.0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2.4 ± 22.4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1.1 ± 9.5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8.1 ± 6.6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16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3.7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± 25.9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2.6 ± 35.6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7.1 ± 7.8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2.6 ± 8.7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18.9 ± 28.0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1.1± 35.8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4.1 ± 12.6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9.9 ± 9.0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5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16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3 ± 11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3± 17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18.0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± 14.8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20.0 ± 32.3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9.5 ± 8.0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8.5 ± 4.0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4.3 ± 19.6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24.5 ± 36.2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4.3 ± 7.3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8.8 ± 1.5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16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5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48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1.3 ± 12.4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3.5 ± 13.2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7.4 ± 6.9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0.6 ± 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9.7 ± 13.4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6.7 ± 13.4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8.0 ± 6.6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1.0 ± 5.0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37:46Z</dcterms:modified>
  <cp:revision>32</cp:revision>
  <dc:subject/>
  <dc:title>Slide 1</dc:title>
</cp:coreProperties>
</file>